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55448" y="6096000"/>
            <a:ext cx="8862822" cy="838200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-c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Hierarchical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er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is of DEGs in comparison groups: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182 genes that overlapped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IR-s vs. SO-s, IS-s vs. IR-s and IA-s vs. IR-s pairwise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sons;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87 genes that overlapped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IR-s vs. SO-s, IS-s vs. IR-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ut not IA-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IR-s pairwise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sons;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264 genes that overlapped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IR-s vs. SO-s,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A-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IR-s but not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-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IR-s pairwise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sons. Only those genes with cut-off &gt;1.5 and </a:t>
            </a:r>
            <a:r>
              <a:rPr lang="en-US" sz="14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arison of RNA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ults under IR,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max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ACTH(6-9)PGP peptides action in striatum at 24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 afte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2" name="Picture 2" descr="K:\Редактируемые\Для публикаций\0_текущие публикации\ишемия_2\стриатум 24h\статья по 24 часам striat\2_pept-str\вар2\fs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1066800"/>
            <a:ext cx="7123112" cy="42644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129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4</cp:revision>
  <dcterms:created xsi:type="dcterms:W3CDTF">2006-08-16T00:00:00Z</dcterms:created>
  <dcterms:modified xsi:type="dcterms:W3CDTF">2025-03-03T16:32:28Z</dcterms:modified>
</cp:coreProperties>
</file>